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66" r:id="rId3"/>
    <p:sldId id="269" r:id="rId4"/>
    <p:sldId id="268" r:id="rId5"/>
    <p:sldId id="270" r:id="rId6"/>
  </p:sldIdLst>
  <p:sldSz cx="6858000" cy="9144000" type="screen4x3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6667" autoAdjust="0"/>
    <p:restoredTop sz="94660"/>
  </p:normalViewPr>
  <p:slideViewPr>
    <p:cSldViewPr snapToGrid="0">
      <p:cViewPr varScale="1">
        <p:scale>
          <a:sx n="87" d="100"/>
          <a:sy n="87" d="100"/>
        </p:scale>
        <p:origin x="3648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mu&#241;oz\Desktop\varios%20ESTHER%20MOREL\Papers\Paper%20CD38\Reviewers\Analisis%20CD38A%20Br%20German%20&amp;%20Esther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mu&#241;oz\Desktop\varios%20ESTHER%20MOREL\Papers\Paper%20CD38\Reviewers\Copia%20de%20CD38%20y%20CD11b%20en%20DISTINTOS%20ORGANOS%20(1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mu&#241;oz\Desktop\varios%20ESTHER%20MOREL\Papers\Paper%20CD38\Reviewers\Copia%20de%20CD38%20y%20CD11b%20en%20DISTINTOS%20ORGANOS%20(1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0!$J$38:$L$38</c:f>
                <c:numCache>
                  <c:formatCode>General</c:formatCode>
                  <c:ptCount val="3"/>
                  <c:pt idx="0">
                    <c:v>1.4995017354259568</c:v>
                  </c:pt>
                  <c:pt idx="1">
                    <c:v>0.1463914428696384</c:v>
                  </c:pt>
                  <c:pt idx="2">
                    <c:v>1.94065593409688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0!$J$36:$L$36</c:f>
              <c:strCache>
                <c:ptCount val="3"/>
                <c:pt idx="0">
                  <c:v>IgM+CD38A-</c:v>
                </c:pt>
                <c:pt idx="1">
                  <c:v>IgM+CD38A+</c:v>
                </c:pt>
                <c:pt idx="2">
                  <c:v>IgM-CD38A+</c:v>
                </c:pt>
              </c:strCache>
            </c:strRef>
          </c:cat>
          <c:val>
            <c:numRef>
              <c:f>Sheet0!$J$37:$L$37</c:f>
              <c:numCache>
                <c:formatCode>0.00</c:formatCode>
                <c:ptCount val="3"/>
                <c:pt idx="0">
                  <c:v>3.2536363636363634</c:v>
                </c:pt>
                <c:pt idx="1">
                  <c:v>0.31736363636363635</c:v>
                </c:pt>
                <c:pt idx="2">
                  <c:v>4.22363636363636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85-4AF9-92EA-7D2009B03F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8948960"/>
        <c:axId val="428946216"/>
      </c:barChart>
      <c:catAx>
        <c:axId val="4289489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28946216"/>
        <c:crosses val="autoZero"/>
        <c:auto val="1"/>
        <c:lblAlgn val="ctr"/>
        <c:lblOffset val="100"/>
        <c:noMultiLvlLbl val="0"/>
      </c:catAx>
      <c:valAx>
        <c:axId val="42894621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289489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raficos B y S'!$D$24:$F$24</c:f>
                <c:numCache>
                  <c:formatCode>General</c:formatCode>
                  <c:ptCount val="3"/>
                  <c:pt idx="0">
                    <c:v>10.487059991853172</c:v>
                  </c:pt>
                  <c:pt idx="1">
                    <c:v>0.31615876333950277</c:v>
                  </c:pt>
                  <c:pt idx="2">
                    <c:v>0.255385626419769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1]Sheet0!$J$36:$L$36</c:f>
              <c:strCache>
                <c:ptCount val="3"/>
                <c:pt idx="0">
                  <c:v>IgM+CD38A-</c:v>
                </c:pt>
                <c:pt idx="1">
                  <c:v>IgM+CD38A+</c:v>
                </c:pt>
                <c:pt idx="2">
                  <c:v>IgM-CD38A+</c:v>
                </c:pt>
              </c:strCache>
            </c:strRef>
          </c:cat>
          <c:val>
            <c:numRef>
              <c:f>'graficos B y S'!$D$23:$F$23</c:f>
              <c:numCache>
                <c:formatCode>General</c:formatCode>
                <c:ptCount val="3"/>
                <c:pt idx="0">
                  <c:v>28.775454545454544</c:v>
                </c:pt>
                <c:pt idx="1">
                  <c:v>0.58181818181818179</c:v>
                </c:pt>
                <c:pt idx="2">
                  <c:v>0.787272727272727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C4-4EE0-800E-1AB223B84B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8946608"/>
        <c:axId val="428945432"/>
      </c:barChart>
      <c:catAx>
        <c:axId val="428946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28945432"/>
        <c:crosses val="autoZero"/>
        <c:auto val="1"/>
        <c:lblAlgn val="ctr"/>
        <c:lblOffset val="100"/>
        <c:noMultiLvlLbl val="0"/>
      </c:catAx>
      <c:valAx>
        <c:axId val="428945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289466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raficos B y S'!$D$60:$F$60</c:f>
                <c:numCache>
                  <c:formatCode>General</c:formatCode>
                  <c:ptCount val="3"/>
                  <c:pt idx="0">
                    <c:v>15.866064414340437</c:v>
                  </c:pt>
                  <c:pt idx="1">
                    <c:v>0.40652406839179683</c:v>
                  </c:pt>
                  <c:pt idx="2">
                    <c:v>0.245564285232642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1]Sheet0!$J$36:$L$36</c:f>
              <c:strCache>
                <c:ptCount val="3"/>
                <c:pt idx="0">
                  <c:v>IgM+CD38A-</c:v>
                </c:pt>
                <c:pt idx="1">
                  <c:v>IgM+CD38A+</c:v>
                </c:pt>
                <c:pt idx="2">
                  <c:v>IgM-CD38A+</c:v>
                </c:pt>
              </c:strCache>
            </c:strRef>
          </c:cat>
          <c:val>
            <c:numRef>
              <c:f>'graficos B y S'!$D$59:$F$59</c:f>
              <c:numCache>
                <c:formatCode>General</c:formatCode>
                <c:ptCount val="3"/>
                <c:pt idx="0">
                  <c:v>37.1</c:v>
                </c:pt>
                <c:pt idx="1">
                  <c:v>0.85272727272727267</c:v>
                </c:pt>
                <c:pt idx="2">
                  <c:v>0.78727272727272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08-441F-868E-F5552655FC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5908824"/>
        <c:axId val="525910392"/>
      </c:barChart>
      <c:catAx>
        <c:axId val="525908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25910392"/>
        <c:crosses val="autoZero"/>
        <c:auto val="1"/>
        <c:lblAlgn val="ctr"/>
        <c:lblOffset val="100"/>
        <c:noMultiLvlLbl val="0"/>
      </c:catAx>
      <c:valAx>
        <c:axId val="525910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259088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4118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145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0196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7583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2062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9859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8407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5868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5875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5863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8137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2428C-5FE8-4C73-9C37-B315C0FF4731}" type="datetimeFigureOut">
              <a:rPr lang="es-ES" smtClean="0"/>
              <a:t>25/10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6A4CF-E7F4-4ECA-80FD-A6F8796247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0167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chart" Target="../charts/chart2.xml"/><Relationship Id="rId7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chart" Target="../charts/chart3.xml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520505" y="4534374"/>
            <a:ext cx="57325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: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inbow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out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8a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ligh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blue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sequence corresponding to the extracellular doma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protein that w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tized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lon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a generate a recombinant protein. This recombinant protein was then used to immunize mice and produce a monoclonal antibody against rainbow trout CD38A. 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Imagen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97" y="599093"/>
            <a:ext cx="5680671" cy="30022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3619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642" y="177231"/>
            <a:ext cx="6521054" cy="7147075"/>
          </a:xfrm>
          <a:prstGeom prst="rect">
            <a:avLst/>
          </a:prstGeom>
        </p:spPr>
      </p:pic>
      <p:sp>
        <p:nvSpPr>
          <p:cNvPr id="4" name="Rectángulo 3"/>
          <p:cNvSpPr/>
          <p:nvPr/>
        </p:nvSpPr>
        <p:spPr>
          <a:xfrm>
            <a:off x="133643" y="7500615"/>
            <a:ext cx="652105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: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3D structure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. mykiss </a:t>
            </a:r>
            <a:r>
              <a:rPr lang="en-US" sz="1200" b="1" cap="all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cap="al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8b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gions encoding alpha helix, beta strand, transmembrane helix or disordered regions for each prote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 together with the confidence of prediction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3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model for each protein i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so show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833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581558" y="139747"/>
            <a:ext cx="5862095" cy="7400185"/>
            <a:chOff x="496214" y="1544875"/>
            <a:chExt cx="5862095" cy="7400185"/>
          </a:xfrm>
        </p:grpSpPr>
        <p:sp>
          <p:nvSpPr>
            <p:cNvPr id="5" name="1 CuadroTexto"/>
            <p:cNvSpPr txBox="1"/>
            <p:nvPr/>
          </p:nvSpPr>
          <p:spPr>
            <a:xfrm rot="16200000">
              <a:off x="4068335" y="7385025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/>
                <a:t>% </a:t>
              </a:r>
              <a:r>
                <a:rPr lang="es-ES" sz="1000" dirty="0" err="1" smtClean="0"/>
                <a:t>cells</a:t>
              </a:r>
              <a:endParaRPr lang="es-ES" sz="1000" dirty="0"/>
            </a:p>
          </p:txBody>
        </p:sp>
        <p:graphicFrame>
          <p:nvGraphicFramePr>
            <p:cNvPr id="6" name="Gráfico 5"/>
            <p:cNvGraphicFramePr>
              <a:graphicFrameLocks/>
            </p:cNvGraphicFramePr>
            <p:nvPr>
              <p:extLst/>
            </p:nvPr>
          </p:nvGraphicFramePr>
          <p:xfrm>
            <a:off x="4407347" y="6652583"/>
            <a:ext cx="1928690" cy="22924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CuadroTexto 6"/>
            <p:cNvSpPr txBox="1"/>
            <p:nvPr/>
          </p:nvSpPr>
          <p:spPr>
            <a:xfrm>
              <a:off x="2982211" y="6538838"/>
              <a:ext cx="5112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 smtClean="0"/>
                <a:t>Gills</a:t>
              </a:r>
              <a:endParaRPr lang="es-ES" sz="1200" b="1" dirty="0"/>
            </a:p>
          </p:txBody>
        </p:sp>
        <p:graphicFrame>
          <p:nvGraphicFramePr>
            <p:cNvPr id="8" name="Gráfico 7"/>
            <p:cNvGraphicFramePr>
              <a:graphicFrameLocks/>
            </p:cNvGraphicFramePr>
            <p:nvPr>
              <p:extLst/>
            </p:nvPr>
          </p:nvGraphicFramePr>
          <p:xfrm>
            <a:off x="4506200" y="4134910"/>
            <a:ext cx="1852109" cy="22924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1 CuadroTexto"/>
            <p:cNvSpPr txBox="1"/>
            <p:nvPr/>
          </p:nvSpPr>
          <p:spPr>
            <a:xfrm rot="16200000">
              <a:off x="4114722" y="4863881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/>
                <a:t>% </a:t>
              </a:r>
              <a:r>
                <a:rPr lang="es-ES" sz="1000" dirty="0" err="1" smtClean="0"/>
                <a:t>cells</a:t>
              </a:r>
              <a:endParaRPr lang="es-ES" sz="1000" dirty="0"/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2966624" y="4016545"/>
              <a:ext cx="6439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/>
                <a:t>Spleen</a:t>
              </a:r>
              <a:endParaRPr lang="es-ES" sz="1200" b="1" dirty="0"/>
            </a:p>
          </p:txBody>
        </p:sp>
        <p:graphicFrame>
          <p:nvGraphicFramePr>
            <p:cNvPr id="11" name="Gráfico 10"/>
            <p:cNvGraphicFramePr>
              <a:graphicFrameLocks/>
            </p:cNvGraphicFramePr>
            <p:nvPr>
              <p:extLst/>
            </p:nvPr>
          </p:nvGraphicFramePr>
          <p:xfrm>
            <a:off x="4477470" y="1664826"/>
            <a:ext cx="1858823" cy="22830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2" name="1 CuadroTexto"/>
            <p:cNvSpPr txBox="1"/>
            <p:nvPr/>
          </p:nvSpPr>
          <p:spPr>
            <a:xfrm rot="16200000">
              <a:off x="4114722" y="2393797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/>
                <a:t>% </a:t>
              </a:r>
              <a:r>
                <a:rPr lang="es-ES" sz="1000" dirty="0" err="1" smtClean="0"/>
                <a:t>cells</a:t>
              </a:r>
              <a:endParaRPr lang="es-ES" sz="1000" dirty="0"/>
            </a:p>
          </p:txBody>
        </p:sp>
        <p:pic>
          <p:nvPicPr>
            <p:cNvPr id="13" name="Imagen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8063" y="4211742"/>
              <a:ext cx="1648890" cy="1788981"/>
            </a:xfrm>
            <a:prstGeom prst="rect">
              <a:avLst/>
            </a:prstGeom>
          </p:spPr>
        </p:pic>
        <p:cxnSp>
          <p:nvCxnSpPr>
            <p:cNvPr id="14" name="Conector recto de flecha 13"/>
            <p:cNvCxnSpPr/>
            <p:nvPr/>
          </p:nvCxnSpPr>
          <p:spPr>
            <a:xfrm flipV="1">
              <a:off x="611630" y="4747029"/>
              <a:ext cx="0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" name="Imagen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86914" y="4229230"/>
              <a:ext cx="1603367" cy="1754004"/>
            </a:xfrm>
            <a:prstGeom prst="rect">
              <a:avLst/>
            </a:prstGeom>
          </p:spPr>
        </p:pic>
        <p:cxnSp>
          <p:nvCxnSpPr>
            <p:cNvPr id="16" name="Conector recto de flecha 15"/>
            <p:cNvCxnSpPr/>
            <p:nvPr/>
          </p:nvCxnSpPr>
          <p:spPr>
            <a:xfrm>
              <a:off x="611630" y="6026867"/>
              <a:ext cx="1371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uadroTexto 16"/>
            <p:cNvSpPr txBox="1"/>
            <p:nvPr/>
          </p:nvSpPr>
          <p:spPr>
            <a:xfrm rot="16200000">
              <a:off x="260901" y="4493875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1783562" y="5901926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Conector recto de flecha 18"/>
            <p:cNvCxnSpPr/>
            <p:nvPr/>
          </p:nvCxnSpPr>
          <p:spPr>
            <a:xfrm flipV="1">
              <a:off x="2478530" y="4747029"/>
              <a:ext cx="0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ctor recto de flecha 19"/>
            <p:cNvCxnSpPr/>
            <p:nvPr/>
          </p:nvCxnSpPr>
          <p:spPr>
            <a:xfrm>
              <a:off x="2478530" y="6026867"/>
              <a:ext cx="1371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CuadroTexto 20"/>
            <p:cNvSpPr txBox="1"/>
            <p:nvPr/>
          </p:nvSpPr>
          <p:spPr>
            <a:xfrm rot="16200000">
              <a:off x="2127801" y="4493875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3488537" y="5901926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Texto 39"/>
            <p:cNvSpPr txBox="1"/>
            <p:nvPr/>
          </p:nvSpPr>
          <p:spPr>
            <a:xfrm>
              <a:off x="2689557" y="4437920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6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3556205" y="4437920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39"/>
            <p:cNvSpPr txBox="1"/>
            <p:nvPr/>
          </p:nvSpPr>
          <p:spPr>
            <a:xfrm>
              <a:off x="3556205" y="5491088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.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Imagen 2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7212" y="1720944"/>
              <a:ext cx="1669741" cy="1815125"/>
            </a:xfrm>
            <a:prstGeom prst="rect">
              <a:avLst/>
            </a:prstGeom>
          </p:spPr>
        </p:pic>
        <p:pic>
          <p:nvPicPr>
            <p:cNvPr id="27" name="Imagen 2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496699" y="1767924"/>
              <a:ext cx="1593582" cy="1763529"/>
            </a:xfrm>
            <a:prstGeom prst="rect">
              <a:avLst/>
            </a:prstGeom>
          </p:spPr>
        </p:pic>
        <p:sp>
          <p:nvSpPr>
            <p:cNvPr id="28" name="CuadroTexto 27"/>
            <p:cNvSpPr txBox="1"/>
            <p:nvPr/>
          </p:nvSpPr>
          <p:spPr>
            <a:xfrm>
              <a:off x="2966624" y="1544875"/>
              <a:ext cx="6439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 smtClean="0"/>
                <a:t>Blood</a:t>
              </a:r>
              <a:endParaRPr lang="es-ES" sz="1200" b="1" dirty="0"/>
            </a:p>
          </p:txBody>
        </p:sp>
        <p:cxnSp>
          <p:nvCxnSpPr>
            <p:cNvPr id="29" name="Conector recto de flecha 28"/>
            <p:cNvCxnSpPr/>
            <p:nvPr/>
          </p:nvCxnSpPr>
          <p:spPr>
            <a:xfrm flipV="1">
              <a:off x="611630" y="2275359"/>
              <a:ext cx="0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de flecha 29"/>
            <p:cNvCxnSpPr/>
            <p:nvPr/>
          </p:nvCxnSpPr>
          <p:spPr>
            <a:xfrm>
              <a:off x="611630" y="3759917"/>
              <a:ext cx="1371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CuadroTexto 30"/>
            <p:cNvSpPr txBox="1"/>
            <p:nvPr/>
          </p:nvSpPr>
          <p:spPr>
            <a:xfrm rot="16200000">
              <a:off x="260901" y="2022205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1783562" y="3430256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Conector recto de flecha 32"/>
            <p:cNvCxnSpPr/>
            <p:nvPr/>
          </p:nvCxnSpPr>
          <p:spPr>
            <a:xfrm flipV="1">
              <a:off x="2478530" y="2275359"/>
              <a:ext cx="0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ctor recto de flecha 33"/>
            <p:cNvCxnSpPr/>
            <p:nvPr/>
          </p:nvCxnSpPr>
          <p:spPr>
            <a:xfrm>
              <a:off x="2478530" y="3759917"/>
              <a:ext cx="1371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uadroTexto 34"/>
            <p:cNvSpPr txBox="1"/>
            <p:nvPr/>
          </p:nvSpPr>
          <p:spPr>
            <a:xfrm rot="16200000">
              <a:off x="2127801" y="2022205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3488537" y="3430256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uadroTexto 39"/>
            <p:cNvSpPr txBox="1"/>
            <p:nvPr/>
          </p:nvSpPr>
          <p:spPr>
            <a:xfrm>
              <a:off x="2689557" y="1966250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2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3556205" y="1966250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7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uadroTexto 39"/>
            <p:cNvSpPr txBox="1"/>
            <p:nvPr/>
          </p:nvSpPr>
          <p:spPr>
            <a:xfrm>
              <a:off x="3556205" y="3019418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.7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Imagen 3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08212" y="6727638"/>
              <a:ext cx="1668592" cy="1805227"/>
            </a:xfrm>
            <a:prstGeom prst="rect">
              <a:avLst/>
            </a:prstGeom>
          </p:spPr>
        </p:pic>
        <p:pic>
          <p:nvPicPr>
            <p:cNvPr id="41" name="Imagen 4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485966" y="6753248"/>
              <a:ext cx="1605262" cy="1754005"/>
            </a:xfrm>
            <a:prstGeom prst="rect">
              <a:avLst/>
            </a:prstGeom>
          </p:spPr>
        </p:pic>
        <p:sp>
          <p:nvSpPr>
            <p:cNvPr id="42" name="CuadroTexto 39"/>
            <p:cNvSpPr txBox="1"/>
            <p:nvPr/>
          </p:nvSpPr>
          <p:spPr>
            <a:xfrm>
              <a:off x="2705477" y="6965030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6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3572125" y="6965030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uadroTexto 39"/>
            <p:cNvSpPr txBox="1"/>
            <p:nvPr/>
          </p:nvSpPr>
          <p:spPr>
            <a:xfrm>
              <a:off x="3572125" y="8018198"/>
              <a:ext cx="475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Conector recto de flecha 44"/>
            <p:cNvCxnSpPr/>
            <p:nvPr/>
          </p:nvCxnSpPr>
          <p:spPr>
            <a:xfrm flipV="1">
              <a:off x="613902" y="7287785"/>
              <a:ext cx="0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recto de flecha 45"/>
            <p:cNvCxnSpPr/>
            <p:nvPr/>
          </p:nvCxnSpPr>
          <p:spPr>
            <a:xfrm>
              <a:off x="613902" y="8567623"/>
              <a:ext cx="1371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CuadroTexto 46"/>
            <p:cNvSpPr txBox="1"/>
            <p:nvPr/>
          </p:nvSpPr>
          <p:spPr>
            <a:xfrm rot="16200000">
              <a:off x="263173" y="7034631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1785834" y="8442682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Conector recto de flecha 48"/>
            <p:cNvCxnSpPr/>
            <p:nvPr/>
          </p:nvCxnSpPr>
          <p:spPr>
            <a:xfrm flipV="1">
              <a:off x="2480802" y="7287785"/>
              <a:ext cx="0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cto de flecha 49"/>
            <p:cNvCxnSpPr/>
            <p:nvPr/>
          </p:nvCxnSpPr>
          <p:spPr>
            <a:xfrm>
              <a:off x="2480802" y="8567623"/>
              <a:ext cx="1371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CuadroTexto 50"/>
            <p:cNvSpPr txBox="1"/>
            <p:nvPr/>
          </p:nvSpPr>
          <p:spPr>
            <a:xfrm rot="16200000">
              <a:off x="2130073" y="7034631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3490809" y="8442682"/>
              <a:ext cx="701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Rectángulo 52"/>
          <p:cNvSpPr/>
          <p:nvPr/>
        </p:nvSpPr>
        <p:spPr>
          <a:xfrm>
            <a:off x="113414" y="7666195"/>
            <a:ext cx="674458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blood, spleen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l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 populations expressing CD38A on the cell surface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s were stained with DAPI and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ainst IgM and CD38A. For each sample, FSC/SSC profiles were used to define lymphoid gates. Single cells were identified by plotting FSC-H/FSC-A profiles. DAPI negative cells within the singlet gate were gated in order to select live cells. The percentage of Ig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A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g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A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g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A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as then established among live singlet lymphoid cells. Representative dot plots are shown along with a graph showing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percentage of the different cell subsets + SD (n=11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05367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21185" y="198304"/>
            <a:ext cx="35052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 study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5720325"/>
              </p:ext>
            </p:extLst>
          </p:nvPr>
        </p:nvGraphicFramePr>
        <p:xfrm>
          <a:off x="241712" y="1120156"/>
          <a:ext cx="5969173" cy="2152655"/>
        </p:xfrm>
        <a:graphic>
          <a:graphicData uri="http://schemas.openxmlformats.org/drawingml/2006/table">
            <a:tbl>
              <a:tblPr firstRow="1" firstCol="1" bandRow="1"/>
              <a:tblGrid>
                <a:gridCol w="749728">
                  <a:extLst>
                    <a:ext uri="{9D8B030D-6E8A-4147-A177-3AD203B41FA5}">
                      <a16:colId xmlns:a16="http://schemas.microsoft.com/office/drawing/2014/main" val="1699563939"/>
                    </a:ext>
                  </a:extLst>
                </a:gridCol>
                <a:gridCol w="2646732">
                  <a:extLst>
                    <a:ext uri="{9D8B030D-6E8A-4147-A177-3AD203B41FA5}">
                      <a16:colId xmlns:a16="http://schemas.microsoft.com/office/drawing/2014/main" val="2212601483"/>
                    </a:ext>
                  </a:extLst>
                </a:gridCol>
                <a:gridCol w="2572713">
                  <a:extLst>
                    <a:ext uri="{9D8B030D-6E8A-4147-A177-3AD203B41FA5}">
                      <a16:colId xmlns:a16="http://schemas.microsoft.com/office/drawing/2014/main" val="52628750"/>
                    </a:ext>
                  </a:extLst>
                </a:gridCol>
              </a:tblGrid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 (5’-3’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 (5’-3’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6072615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8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AGTGCAAACAACTGTCAAAAGA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GGCCTCCATCGGTACATTACA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2817051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8b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CCCTGTGCTAACAGCCTA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CACTGAAAAGTGACAGCCTAC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6834121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dm1a-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GCGCCCCAGTCAAGAT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GGTAGAGGGCACAGC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7065975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dm1a-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TCGGCCCTATGTGTG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CCTCGGTAGTCAACATGG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0312962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dm1c-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CTGCATCAACACCGAG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GGTCTCCATCACCATCTT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351397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dm1c-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CAATGGGAATATGTCAC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CATAGCCAGGATGCAGAGG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0351292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rf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ATCACCATAGCAACAC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CTCTCCCCAGGCTTTCT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010279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x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GGAGATCGGATGTTCCTCT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TGCCGCGCTGTAGTAGTAC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0171310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cm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cap="all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tcagaaggacagtgtggactg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cap="all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GCTCTGGGGCTTTGCTCT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189528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1α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TCCAGAAGGAGGTCAC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ACGTTCGACCTTCCATCC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45025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30907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98303" y="275422"/>
            <a:ext cx="637876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 values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house-keeping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EF1α) along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samples analyzed in this study. 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08" y="1469255"/>
            <a:ext cx="6676223" cy="1168339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308" y="3220171"/>
            <a:ext cx="1613420" cy="731205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308" y="4524637"/>
            <a:ext cx="2781760" cy="969642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1308" y="5988314"/>
            <a:ext cx="1223974" cy="1128600"/>
          </a:xfrm>
          <a:prstGeom prst="rect">
            <a:avLst/>
          </a:prstGeom>
        </p:spPr>
      </p:pic>
      <p:sp>
        <p:nvSpPr>
          <p:cNvPr id="11" name="CuadroTexto 10"/>
          <p:cNvSpPr txBox="1"/>
          <p:nvPr/>
        </p:nvSpPr>
        <p:spPr>
          <a:xfrm>
            <a:off x="121308" y="1110227"/>
            <a:ext cx="2761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itutive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38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ssues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121308" y="2865066"/>
            <a:ext cx="30673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itutive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38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rted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121308" y="4161686"/>
            <a:ext cx="3132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CD38 in VHSV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sh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121308" y="5693101"/>
            <a:ext cx="3537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ti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rted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44713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63</TotalTime>
  <Words>352</Words>
  <Application>Microsoft Office PowerPoint</Application>
  <PresentationFormat>Presentación en pantalla (4:3)</PresentationFormat>
  <Paragraphs>69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olina Tafalla</dc:creator>
  <cp:lastModifiedBy>Carolina Tafalla</cp:lastModifiedBy>
  <cp:revision>91</cp:revision>
  <cp:lastPrinted>2021-05-13T09:22:59Z</cp:lastPrinted>
  <dcterms:created xsi:type="dcterms:W3CDTF">2019-11-22T11:32:47Z</dcterms:created>
  <dcterms:modified xsi:type="dcterms:W3CDTF">2021-10-25T12:01:06Z</dcterms:modified>
</cp:coreProperties>
</file>